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69" d="100"/>
          <a:sy n="69" d="100"/>
        </p:scale>
        <p:origin x="96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863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299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933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373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008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150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486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419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725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02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871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408C49-5A03-4557-8BE6-6F9FC94C3BF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56CA08-7BC4-486B-A1B7-B2ABF37082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873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3474848" y="521521"/>
            <a:ext cx="54144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Examination of chronically infected mice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ight Arrow 4"/>
          <p:cNvSpPr/>
          <p:nvPr/>
        </p:nvSpPr>
        <p:spPr>
          <a:xfrm>
            <a:off x="2109336" y="3000593"/>
            <a:ext cx="6324600" cy="304800"/>
          </a:xfrm>
          <a:prstGeom prst="rightArrow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Down Arrow 5"/>
          <p:cNvSpPr/>
          <p:nvPr/>
        </p:nvSpPr>
        <p:spPr>
          <a:xfrm>
            <a:off x="4612137" y="2594811"/>
            <a:ext cx="152400" cy="381000"/>
          </a:xfrm>
          <a:prstGeom prst="down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4093449" y="230631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Down Arrow 8"/>
          <p:cNvSpPr/>
          <p:nvPr/>
        </p:nvSpPr>
        <p:spPr>
          <a:xfrm>
            <a:off x="2125201" y="2591020"/>
            <a:ext cx="152400" cy="381000"/>
          </a:xfrm>
          <a:prstGeom prst="down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2065243" y="2242491"/>
            <a:ext cx="2723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208398" y="2942277"/>
            <a:ext cx="8568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LB/c</a:t>
            </a: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</a:p>
          <a:p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eft Brace 12"/>
          <p:cNvSpPr/>
          <p:nvPr/>
        </p:nvSpPr>
        <p:spPr>
          <a:xfrm rot="5400000">
            <a:off x="3186447" y="862444"/>
            <a:ext cx="458825" cy="2428918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Left Brace 13"/>
          <p:cNvSpPr/>
          <p:nvPr/>
        </p:nvSpPr>
        <p:spPr>
          <a:xfrm rot="5400000">
            <a:off x="5856787" y="771584"/>
            <a:ext cx="458825" cy="2610638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2945219" y="1469066"/>
            <a:ext cx="18834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. Acute Phase (~21 days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236884" y="1465440"/>
            <a:ext cx="1339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. Chronic Phase</a:t>
            </a:r>
            <a:endParaRPr lang="en-US" sz="1200" b="1" dirty="0">
              <a:solidFill>
                <a:srgbClr val="C00000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526619" y="1469066"/>
            <a:ext cx="167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~22-70 Days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 flipV="1">
            <a:off x="2337559" y="2781520"/>
            <a:ext cx="2274578" cy="3791"/>
          </a:xfrm>
          <a:prstGeom prst="straightConnector1">
            <a:avLst/>
          </a:prstGeom>
          <a:ln w="12700">
            <a:solidFill>
              <a:srgbClr val="C0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2716618" y="2529151"/>
            <a:ext cx="10246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-Day LD</a:t>
            </a:r>
            <a:r>
              <a:rPr lang="en-US" sz="14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4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ight Brace 21"/>
          <p:cNvSpPr/>
          <p:nvPr/>
        </p:nvSpPr>
        <p:spPr>
          <a:xfrm rot="5400000">
            <a:off x="6238536" y="1883118"/>
            <a:ext cx="284086" cy="3199399"/>
          </a:xfrm>
          <a:prstGeom prst="rightBrac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1928063" y="1192068"/>
            <a:ext cx="291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 LD</a:t>
            </a:r>
            <a:r>
              <a:rPr lang="en-US" sz="12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 to obtain relative virulence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956444" y="3638703"/>
            <a:ext cx="73895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nic infection study	 Select survivors from acute phase, LD</a:t>
            </a:r>
            <a:r>
              <a:rPr lang="en-US" sz="12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udy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6393300" y="3946480"/>
            <a:ext cx="0" cy="17525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4630319" y="4521067"/>
            <a:ext cx="3767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um			Spleens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Straight Arrow Connector 33"/>
          <p:cNvCxnSpPr/>
          <p:nvPr/>
        </p:nvCxnSpPr>
        <p:spPr>
          <a:xfrm flipH="1">
            <a:off x="5331149" y="4333162"/>
            <a:ext cx="924507" cy="24816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6526619" y="4347217"/>
            <a:ext cx="864900" cy="24816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8" name="Group 57"/>
          <p:cNvGrpSpPr/>
          <p:nvPr/>
        </p:nvGrpSpPr>
        <p:grpSpPr>
          <a:xfrm>
            <a:off x="4262726" y="4705906"/>
            <a:ext cx="6013836" cy="1520619"/>
            <a:chOff x="4262726" y="4269060"/>
            <a:chExt cx="6013836" cy="1520619"/>
          </a:xfrm>
        </p:grpSpPr>
        <p:cxnSp>
          <p:nvCxnSpPr>
            <p:cNvPr id="38" name="Straight Arrow Connector 37"/>
            <p:cNvCxnSpPr/>
            <p:nvPr/>
          </p:nvCxnSpPr>
          <p:spPr>
            <a:xfrm>
              <a:off x="4954772" y="4475566"/>
              <a:ext cx="0" cy="16517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4262726" y="4654664"/>
              <a:ext cx="165462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body </a:t>
              </a:r>
            </a:p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tokines/chemokines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7521422" y="4558153"/>
              <a:ext cx="6815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tract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4" name="Straight Arrow Connector 43"/>
            <p:cNvCxnSpPr/>
            <p:nvPr/>
          </p:nvCxnSpPr>
          <p:spPr>
            <a:xfrm>
              <a:off x="7862220" y="4455766"/>
              <a:ext cx="0" cy="1988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 flipH="1">
              <a:off x="7308771" y="4770983"/>
              <a:ext cx="270017" cy="15151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6751622" y="4881026"/>
              <a:ext cx="16546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FU</a:t>
              </a:r>
            </a:p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tokines/chemokines</a:t>
              </a:r>
            </a:p>
            <a:p>
              <a:r>
                <a:rPr lang="en-US" sz="1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 vivo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lture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8433936" y="4834859"/>
              <a:ext cx="12170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 cytometry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0" name="Straight Arrow Connector 49"/>
            <p:cNvCxnSpPr/>
            <p:nvPr/>
          </p:nvCxnSpPr>
          <p:spPr>
            <a:xfrm>
              <a:off x="8135937" y="4770301"/>
              <a:ext cx="290987" cy="13099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9036565" y="5111858"/>
              <a:ext cx="0" cy="23083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8406242" y="5328014"/>
              <a:ext cx="187032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ular composition</a:t>
              </a:r>
            </a:p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racellular TNF</a:t>
              </a:r>
              <a:r>
                <a:rPr lang="el-G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IFN</a:t>
              </a:r>
              <a:r>
                <a:rPr lang="el-G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γ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6" name="Straight Arrow Connector 55"/>
            <p:cNvCxnSpPr/>
            <p:nvPr/>
          </p:nvCxnSpPr>
          <p:spPr>
            <a:xfrm>
              <a:off x="8135937" y="4400833"/>
              <a:ext cx="34555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8404147" y="4269060"/>
              <a:ext cx="17808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hology, select spleens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9" name="TextBox 58"/>
          <p:cNvSpPr txBox="1"/>
          <p:nvPr/>
        </p:nvSpPr>
        <p:spPr>
          <a:xfrm>
            <a:off x="5906522" y="4036465"/>
            <a:ext cx="37444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 mouse (including naïve control mice)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9518863" y="6468573"/>
            <a:ext cx="1888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_FigS1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9562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76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DH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emiya, Kei Dr. VOL USARMY MEDCOM USAMRIID (US)</dc:creator>
  <cp:lastModifiedBy>Amemiya, Kei Dr. VOL USARMY MEDCOM USAMRIID (US)</cp:lastModifiedBy>
  <cp:revision>11</cp:revision>
  <cp:lastPrinted>2019-02-21T20:32:14Z</cp:lastPrinted>
  <dcterms:created xsi:type="dcterms:W3CDTF">2019-02-21T13:54:01Z</dcterms:created>
  <dcterms:modified xsi:type="dcterms:W3CDTF">2019-11-14T15:48:19Z</dcterms:modified>
</cp:coreProperties>
</file>